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3BDC8-A607-4E09-9FBA-9CF8C53BC7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15B599-7FB0-4750-9643-2CAA307C60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8EC0C9-1EA0-4153-9FED-7538B87A5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C3B5B8-CE93-460F-9794-19772CDCB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C47FBB-240E-4484-ADE9-547303AB2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21328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11039-132D-4CD7-B001-97CAD5AE4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9CB183-1B7F-4D72-988D-016F6FA50D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73A38-A37B-469C-BD7B-B8FDD6DAD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4F9D0-D36A-4558-8EAC-F94C873F2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69086-AD5E-4C10-9882-58F304886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85149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10FC59-D9A6-44BA-8E3E-8134BB16B5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0C7F8-9C65-4C76-B5BD-3BD8D632BB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634CE4-9CAB-4B6B-9681-6E38D6A7A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FBA405-2F0C-4D69-9173-67AD87A51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D0DC9-25C3-4C8F-A7E4-2401DDE54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7155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90F1C-A2D7-4B17-80CD-7E9653D14F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15D151-A82F-4F72-B183-80BDC00042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977FC0-C774-49E0-BE5F-72E8F7569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14E318-643B-4608-A83A-C6DF0ED30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EFFF8C-D40D-4A27-B699-D7FBCFADA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52840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2D317-FFDA-438A-8B0D-1FC7140D1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2B7447-DB6C-4C2A-970E-ECEF386D95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8AC7FE-2899-4820-80C2-00D11A821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DC0422-6D92-496A-B652-263A9246F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CE04EA-90A2-4F02-9B0F-0E8E6525C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4704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5505D9-AE62-4797-8E47-3B817C491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176AF5-CE8A-43CE-A94C-25277F5BD1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15C170-1A5A-41AF-B83B-7BAE389EB8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873E8C-7590-4C2A-8BBC-C8072F9B8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319DB1-FA76-480A-9722-75EAF8393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D91F51-0A47-408A-BF96-F904867A6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69182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C08AD-11C2-44BB-864E-5EA4818C0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283DA4-C193-4531-812A-11A7C86D7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81D336-B90E-4CB8-A207-36FD84446C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8DA9D8-E7E1-4472-978A-216589AEAF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014E28-57F5-46F6-906A-DFC460E37B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CD7DD1-DF8D-40AC-AF35-298EFC458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0334DB-64C3-44DD-97DF-A7735B473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05C801-A027-4AF5-A8E2-B3D28840B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56982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240D9-9961-4C70-85FC-24AD25120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F2A710-CD11-492C-925A-7C1AEAE84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20BB6B-F3DD-4673-A99D-CCED490CD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9EE93E-FF47-4B4A-AFFF-38872B4BC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60543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8AD0DC-FB33-4595-9884-ACD22BB5E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8000BD-9BEB-4FD5-86F7-650FAC7B4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7BC82A-E562-43AA-919A-9D5D6AB59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27999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B5BA4-2803-4B0A-92AB-A9A3379B9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564CD9-8F07-4F1C-9A91-228A31FD44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78D0CA-5FB9-441C-8169-D312DA753C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94F5A2-1BA5-460E-9456-EDEC43905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61523C-A5BF-4F53-B852-854297065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F4A7A-F0FE-4841-B449-6F8642788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89844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E4615-56B3-4270-8590-ED96C15E3F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68F554-E8DD-46D5-ABFC-308D697C9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A7E2F3-C93A-4966-AD4A-9D9602EF23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00833A-EADC-4514-8F05-97D6D8583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C71EA2-089F-47CF-80A6-694977739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223247-9C32-42FF-8001-83A7C01C8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39483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478A6D-F321-4CC6-8917-DAAC8E5C04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4F5EDA-7658-4642-9499-5043BE84AA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BEC13F-67C2-4C74-B6F2-7EDBB4630C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EFD0A-F3DB-4EBA-9EA3-EFEA112E99C8}" type="datetimeFigureOut">
              <a:rPr lang="nb-NO" smtClean="0"/>
              <a:t>06.04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8FA2A-3C38-424C-888B-6CDAF7ED41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CD569-37A5-4EF2-BB25-6286C5DE0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5D76A-574F-486B-A48C-9B14DC93CF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45295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5F19009-087A-FC04-4A8A-340F969CC2C9}"/>
              </a:ext>
            </a:extLst>
          </p:cNvPr>
          <p:cNvSpPr txBox="1"/>
          <p:nvPr/>
        </p:nvSpPr>
        <p:spPr>
          <a:xfrm>
            <a:off x="857250" y="390525"/>
            <a:ext cx="11068050" cy="51638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gend figure S2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nges in MRI BME SPARCC scores of the spine for each individual in control and HIIT groups at baseline and 3 months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FIGURE S2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number at the x-axis represents individuals in a descending order according to the baseline value for each variable. In the case of a missing column, it either represents the value 0 or missing for that individual. When representing a missing value, it is noted underneath each chart.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ME - bone marrow edema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ARCC -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ondyloarthriti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Research-Consortium-of-Canada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IT - high intensity interval training 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- baseline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M - 3 months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619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C4DB07A-5D24-425D-B02F-EE6F4828BB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7285" y="725913"/>
            <a:ext cx="4458322" cy="231489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98273B-26B9-4C80-B8A0-136839DE7C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792597"/>
            <a:ext cx="4448796" cy="218152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44D3672-5ED0-415A-8C01-6636467DB0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5802" y="3040811"/>
            <a:ext cx="2188654" cy="268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5071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th Stoklund Thomsen</dc:creator>
  <cp:lastModifiedBy>Ruth Stoklund Thomsen</cp:lastModifiedBy>
  <cp:revision>11</cp:revision>
  <dcterms:created xsi:type="dcterms:W3CDTF">2022-05-23T11:30:48Z</dcterms:created>
  <dcterms:modified xsi:type="dcterms:W3CDTF">2023-04-06T11:49:52Z</dcterms:modified>
</cp:coreProperties>
</file>